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60F56-453F-45E7-A8A0-49D93E4690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0F040-17A3-4FF9-875F-975888E3B1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3C838-B5BE-4523-8F11-8CA9B6EE7D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30C50-FBCB-4DA7-8889-241967EA29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13D58-CEDC-4806-A626-834D548ED2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30425-B1B8-4408-A25D-7A13024039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02EF7-AE4E-4203-AA3A-3016888B87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802FC-93A5-4CAC-AC68-453BBDD00C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31BA3-9734-4D10-B563-385AA92075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ED635-0AC7-438C-9990-1D0ABBC33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DF285-A0C2-426A-9F64-41DCDB002C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BA2D7-31E3-40E1-AF5D-3229FAF03E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F9B0E3-49F9-4991-BDC1-93F21C1A4E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1840" y="974880"/>
            <a:ext cx="6245280" cy="7804800"/>
            <a:chOff x="231840" y="974880"/>
            <a:chExt cx="6245280" cy="7804800"/>
          </a:xfrm>
        </p:grpSpPr>
        <p:sp>
          <p:nvSpPr>
            <p:cNvPr id="42" name=""/>
            <p:cNvSpPr/>
            <p:nvPr/>
          </p:nvSpPr>
          <p:spPr>
            <a:xfrm>
              <a:off x="2898000" y="7101000"/>
              <a:ext cx="101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etwor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rot="16200000">
              <a:off x="-1586160" y="3967200"/>
              <a:ext cx="404244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Mean Execution Time (second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41360" y="974880"/>
              <a:ext cx="5730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upplementary Figure 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" descr=""/>
            <p:cNvPicPr/>
            <p:nvPr/>
          </p:nvPicPr>
          <p:blipFill>
            <a:blip r:embed="rId1"/>
            <a:stretch/>
          </p:blipFill>
          <p:spPr>
            <a:xfrm>
              <a:off x="763560" y="1601640"/>
              <a:ext cx="5484960" cy="548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533520" y="7620120"/>
              <a:ext cx="594360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e average execution time of each algorithm with each network. A dagger (†) directly over a bar indicates that the algorithm halted due to memory exhaustion. The indicated values are, therefore, only a lower bound on the total execution time required for successful completion.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"/>
          <p:cNvGrpSpPr/>
          <p:nvPr/>
        </p:nvGrpSpPr>
        <p:grpSpPr>
          <a:xfrm>
            <a:off x="230040" y="950760"/>
            <a:ext cx="6170760" cy="7189560"/>
            <a:chOff x="230040" y="950760"/>
            <a:chExt cx="6170760" cy="7189560"/>
          </a:xfrm>
        </p:grpSpPr>
        <p:sp>
          <p:nvSpPr>
            <p:cNvPr id="48" name=""/>
            <p:cNvSpPr/>
            <p:nvPr/>
          </p:nvSpPr>
          <p:spPr>
            <a:xfrm>
              <a:off x="2898000" y="7101000"/>
              <a:ext cx="101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etwor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-1848600" y="3998880"/>
              <a:ext cx="456372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Mean Maximum Memory Usage (M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45320" y="950760"/>
              <a:ext cx="261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upplementary Figure 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33520" y="7620120"/>
              <a:ext cx="58672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e average maximum memory consumption of the preprocessing phase of the MS and WW algorithms with each network.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" descr=""/>
            <p:cNvPicPr/>
            <p:nvPr/>
          </p:nvPicPr>
          <p:blipFill>
            <a:blip r:embed="rId1"/>
            <a:stretch/>
          </p:blipFill>
          <p:spPr>
            <a:xfrm>
              <a:off x="762120" y="1601640"/>
              <a:ext cx="5484600" cy="54849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"/>
          <p:cNvGrpSpPr/>
          <p:nvPr/>
        </p:nvGrpSpPr>
        <p:grpSpPr>
          <a:xfrm>
            <a:off x="230040" y="950760"/>
            <a:ext cx="6247080" cy="7828920"/>
            <a:chOff x="230040" y="950760"/>
            <a:chExt cx="6247080" cy="7828920"/>
          </a:xfrm>
        </p:grpSpPr>
        <p:sp>
          <p:nvSpPr>
            <p:cNvPr id="54" name=""/>
            <p:cNvSpPr/>
            <p:nvPr/>
          </p:nvSpPr>
          <p:spPr>
            <a:xfrm>
              <a:off x="2898000" y="7101000"/>
              <a:ext cx="1017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etwor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6200000">
              <a:off x="-1848600" y="3998880"/>
              <a:ext cx="4563720" cy="405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Mean Maximum Memory Usage (M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45320" y="950760"/>
              <a:ext cx="261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Supplementary Figure 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33520" y="7620120"/>
              <a:ext cx="594360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e average maximum memory consumption of the extreme pathway identification phase of each algorithm with each network. A dagger (†) directly over a bar indicates that the algorithm halted due to memory exhaustion. The indicated values are, therefore, only a lower bound on the maximum memory required for successful completion.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" name="" descr=""/>
            <p:cNvPicPr/>
            <p:nvPr/>
          </p:nvPicPr>
          <p:blipFill>
            <a:blip r:embed="rId1"/>
            <a:stretch/>
          </p:blipFill>
          <p:spPr>
            <a:xfrm>
              <a:off x="763560" y="1601640"/>
              <a:ext cx="5484960" cy="54849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1T17:16:54Z</dcterms:created>
  <dc:creator>wright</dc:creator>
  <dc:description/>
  <dc:language>en-US</dc:language>
  <cp:lastModifiedBy>wright</cp:lastModifiedBy>
  <dcterms:modified xsi:type="dcterms:W3CDTF">2008-06-06T04:12:27Z</dcterms:modified>
  <cp:revision>18</cp:revision>
  <dc:subject/>
  <dc:title>Slide 1</dc:title>
</cp:coreProperties>
</file>